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8" r:id="rId2"/>
    <p:sldId id="289" r:id="rId3"/>
    <p:sldId id="290" r:id="rId4"/>
    <p:sldId id="291" r:id="rId5"/>
  </p:sldIdLst>
  <p:sldSz cx="12192000" cy="7772400"/>
  <p:notesSz cx="6799263" cy="9929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0445"/>
    <a:srgbClr val="3C1C3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 autoAdjust="0"/>
    <p:restoredTop sz="98287" autoAdjust="0"/>
  </p:normalViewPr>
  <p:slideViewPr>
    <p:cSldViewPr snapToGrid="0">
      <p:cViewPr>
        <p:scale>
          <a:sx n="70" d="100"/>
          <a:sy n="70" d="100"/>
        </p:scale>
        <p:origin x="-1051" y="-413"/>
      </p:cViewPr>
      <p:guideLst>
        <p:guide orient="horz" pos="2449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FABE69-1E0A-4574-A649-E0734A7515EE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744538"/>
            <a:ext cx="5840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40363" cy="44688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21F534-534B-4480-8E10-8B09B761BC8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1401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72013"/>
            <a:ext cx="9144000" cy="270594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82311"/>
            <a:ext cx="9144000" cy="187653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909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087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13811"/>
            <a:ext cx="2628900" cy="658674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13811"/>
            <a:ext cx="7734300" cy="658674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285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593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37703"/>
            <a:ext cx="10515600" cy="323310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201393"/>
            <a:ext cx="10515600" cy="1700212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195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2069043"/>
            <a:ext cx="5181600" cy="4931517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0680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13809"/>
            <a:ext cx="10515600" cy="150230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92" y="1905320"/>
            <a:ext cx="51577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92" y="2839085"/>
            <a:ext cx="51577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905320"/>
            <a:ext cx="5183187" cy="93376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839085"/>
            <a:ext cx="5183187" cy="41758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01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560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567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1" y="518160"/>
            <a:ext cx="3932237" cy="18135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7" y="1119083"/>
            <a:ext cx="6172201" cy="552344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1" y="2331720"/>
            <a:ext cx="3932237" cy="431980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4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413809"/>
            <a:ext cx="10515600" cy="150230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2069043"/>
            <a:ext cx="10515600" cy="49315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3913A8-8E34-41CC-81BB-EDB2A42CA5DD}" type="datetimeFigureOut">
              <a:rPr lang="en-US" smtClean="0"/>
              <a:pPr/>
              <a:t>8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7203863"/>
            <a:ext cx="41148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7203863"/>
            <a:ext cx="2743200" cy="4138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FFBA4-7A78-4CCA-B840-A60F188FAD8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043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F\Pigeonpea\Articles proof\Fertility Restoration\Validation of Indels\Segregation of Q1 on ICPA 2039 x ICPL 87119\RFQ1_2039x87119 PLATE 5,SAMPLE NO 1 TO 48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5687" y="0"/>
            <a:ext cx="6999514" cy="77827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0" y="2733095"/>
            <a:ext cx="4049486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1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5" name="TextBox 4"/>
          <p:cNvSpPr txBox="1"/>
          <p:nvPr/>
        </p:nvSpPr>
        <p:spPr>
          <a:xfrm rot="16200000">
            <a:off x="4140090" y="1030514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4344687" y="1019624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5086878" y="1169882"/>
            <a:ext cx="5526693" cy="307777"/>
            <a:chOff x="5086878" y="1169882"/>
            <a:chExt cx="5526693" cy="307777"/>
          </a:xfrm>
        </p:grpSpPr>
        <p:sp>
          <p:nvSpPr>
            <p:cNvPr id="8" name="TextBox 7"/>
            <p:cNvSpPr txBox="1"/>
            <p:nvPr/>
          </p:nvSpPr>
          <p:spPr>
            <a:xfrm>
              <a:off x="6641573" y="1169882"/>
              <a:ext cx="11753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22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Straight Arrow Connector 8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oup 17"/>
          <p:cNvGrpSpPr/>
          <p:nvPr/>
        </p:nvGrpSpPr>
        <p:grpSpPr>
          <a:xfrm>
            <a:off x="4660842" y="5665796"/>
            <a:ext cx="6105129" cy="307777"/>
            <a:chOff x="5086878" y="1169882"/>
            <a:chExt cx="5526693" cy="307777"/>
          </a:xfrm>
        </p:grpSpPr>
        <p:sp>
          <p:nvSpPr>
            <p:cNvPr id="19" name="TextBox 18"/>
            <p:cNvSpPr txBox="1"/>
            <p:nvPr/>
          </p:nvSpPr>
          <p:spPr>
            <a:xfrm>
              <a:off x="6641573" y="1169882"/>
              <a:ext cx="11249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23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46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721891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F\Pigeonpea\Articles proof\Fertility Restoration\Validation of Indels\Segregation of Q1 on ICPA 2039 x ICPL 87119\RFQ1_2039x87119 PLATE 5,SAMPLE NO 49 TO 96 23072016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7"/>
          <a:stretch/>
        </p:blipFill>
        <p:spPr bwMode="auto">
          <a:xfrm>
            <a:off x="3363687" y="0"/>
            <a:ext cx="7897617" cy="75247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0" y="2733095"/>
            <a:ext cx="3254829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1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388975" y="952073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553272" y="928067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4295464" y="1169882"/>
            <a:ext cx="6318108" cy="307777"/>
            <a:chOff x="5086878" y="1169882"/>
            <a:chExt cx="55266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6641573" y="1169882"/>
              <a:ext cx="10869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47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70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3635830" y="5665796"/>
            <a:ext cx="6422552" cy="307777"/>
            <a:chOff x="5086878" y="1169882"/>
            <a:chExt cx="5526693" cy="307777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693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7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94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82519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D:\F\Pigeonpea\Articles proof\Fertility Restoration\Validation of Indels\Segregation of Q1 on ICPA 2039 x ICPL 87119\RFQ1_2039x87119 PLATE 8 SAMPLE NO 1 TO 48 2307201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6213" y="0"/>
            <a:ext cx="7961971" cy="7772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" y="2733117"/>
            <a:ext cx="3254829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1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388975" y="952073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553272" y="928067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4295464" y="1169882"/>
            <a:ext cx="6318108" cy="307777"/>
            <a:chOff x="5086878" y="1169882"/>
            <a:chExt cx="55266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6641573" y="1169882"/>
              <a:ext cx="11401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95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16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3820891" y="5665793"/>
            <a:ext cx="7097479" cy="307777"/>
            <a:chOff x="5086878" y="1169882"/>
            <a:chExt cx="5526693" cy="204655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67339" cy="204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17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40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03051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D:\F\Pigeonpea\Articles proof\Fertility Restoration\Validation of Indels\Segregation of Q1 on ICPA 2039 x ICPL 87119\RFQ1_2039x87119 PLATE 8 SAMPLE NO 49 TO 96 2307201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4223" y="-1"/>
            <a:ext cx="7935148" cy="77608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1" y="2733117"/>
            <a:ext cx="3254829" cy="646331"/>
          </a:xfrm>
          <a:prstGeom prst="rect">
            <a:avLst/>
          </a:prstGeom>
          <a:solidFill>
            <a:srgbClr val="FFFF00"/>
          </a:solidFill>
        </p:spPr>
        <p:txBody>
          <a:bodyPr wrap="square">
            <a:spAutoFit/>
          </a:bodyPr>
          <a:lstStyle/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CcLG08_RFQI1</a:t>
            </a:r>
          </a:p>
          <a:p>
            <a:r>
              <a:rPr lang="en-IN" dirty="0" smtClean="0">
                <a:latin typeface="Arial" panose="020B0604020202020204" pitchFamily="34" charset="0"/>
                <a:cs typeface="Arial" panose="020B0604020202020204" pitchFamily="34" charset="0"/>
              </a:rPr>
              <a:t>ICPA 2039 x ICPL 87119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388975" y="952073"/>
            <a:ext cx="10415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CPA 203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3553272" y="928067"/>
            <a:ext cx="1176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CPL 87119</a:t>
            </a:r>
            <a:endParaRPr lang="en-IN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4295464" y="1169882"/>
            <a:ext cx="6318108" cy="307777"/>
            <a:chOff x="5086878" y="1169882"/>
            <a:chExt cx="55266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6641573" y="1169882"/>
              <a:ext cx="120477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41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64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Arrow Connector 10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Arrow Connector 11"/>
            <p:cNvCxnSpPr/>
            <p:nvPr/>
          </p:nvCxnSpPr>
          <p:spPr>
            <a:xfrm>
              <a:off x="7816895" y="1358739"/>
              <a:ext cx="2796676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Group 12"/>
          <p:cNvGrpSpPr/>
          <p:nvPr/>
        </p:nvGrpSpPr>
        <p:grpSpPr>
          <a:xfrm>
            <a:off x="3820891" y="5665793"/>
            <a:ext cx="6705595" cy="506407"/>
            <a:chOff x="5086878" y="1169882"/>
            <a:chExt cx="5526693" cy="204655"/>
          </a:xfrm>
        </p:grpSpPr>
        <p:sp>
          <p:nvSpPr>
            <p:cNvPr id="14" name="TextBox 13"/>
            <p:cNvSpPr txBox="1"/>
            <p:nvPr/>
          </p:nvSpPr>
          <p:spPr>
            <a:xfrm>
              <a:off x="6641573" y="1169882"/>
              <a:ext cx="1072481" cy="2046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F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.165 </a:t>
              </a:r>
              <a:r>
                <a:rPr lang="en-IN" sz="1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 </a:t>
              </a:r>
              <a:r>
                <a:rPr lang="en-IN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r>
                <a:rPr lang="en-IN" sz="1400" b="1" baseline="-250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IN" sz="1400" b="1" baseline="-250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.188</a:t>
              </a:r>
              <a:endParaRPr lang="en-IN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5086878" y="1323770"/>
              <a:ext cx="1673151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>
              <a:off x="7696688" y="1326081"/>
              <a:ext cx="2916883" cy="0"/>
            </a:xfrm>
            <a:prstGeom prst="straightConnector1">
              <a:avLst/>
            </a:prstGeom>
            <a:ln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8834244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2</TotalTime>
  <Words>108</Words>
  <Application>Microsoft Office PowerPoint</Application>
  <PresentationFormat>Custom</PresentationFormat>
  <Paragraphs>2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Saxena, Rachit (ICRISAT-IN)</cp:lastModifiedBy>
  <cp:revision>158</cp:revision>
  <dcterms:created xsi:type="dcterms:W3CDTF">2014-11-24T17:11:55Z</dcterms:created>
  <dcterms:modified xsi:type="dcterms:W3CDTF">2016-08-01T03:52:42Z</dcterms:modified>
</cp:coreProperties>
</file>